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90E1F7-0F71-4AD6-A83E-2FA899D712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87990-BAA6-44EB-A276-FFD7B91520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7A353-AC81-4EA8-8C08-47D8CEBE2B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41D9A-B6F6-4AFD-B299-EDCD148954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D858B-7EB1-429B-8735-A13F1D0378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9B64B1-D80E-48A8-9ED4-6F9C2F388F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770F2-3ED2-4BE0-BBA7-39AC9A1CC3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AE374B-0B68-421A-B35E-FEE7ADF933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1FE1A-3E8C-4D74-A304-2A8D1FC394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1809C-B206-4738-8B29-35753D04DF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CF381-AA89-4535-8DB8-61EFB9ACA6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A88CB-4012-4DCB-BF6B-96FAB1C469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97D606-12DC-436F-AF94-32EFBA59C3F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Freeform 2"/>
          <p:cNvGrpSpPr/>
          <p:nvPr/>
        </p:nvGrpSpPr>
        <p:grpSpPr>
          <a:xfrm>
            <a:off x="-6480" y="108000"/>
            <a:ext cx="8261640" cy="9535320"/>
            <a:chOff x="-6480" y="108000"/>
            <a:chExt cx="8261640" cy="9535320"/>
          </a:xfrm>
        </p:grpSpPr>
        <p:pic>
          <p:nvPicPr>
            <p:cNvPr id="42" name="Freeform 2" descr=""/>
            <p:cNvPicPr/>
            <p:nvPr/>
          </p:nvPicPr>
          <p:blipFill>
            <a:blip r:embed="rId1"/>
            <a:stretch/>
          </p:blipFill>
          <p:spPr>
            <a:xfrm>
              <a:off x="-6480" y="952200"/>
              <a:ext cx="7089840" cy="8167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 rot="3823800">
              <a:off x="104760" y="2277360"/>
              <a:ext cx="8068680" cy="519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4" name="Picture 2" descr="G:\Projects\Longhorns, Leucinodes and Tuta\Leucinodes\Leucinodes images\DSCN7214.JPG"/>
          <p:cNvPicPr/>
          <p:nvPr/>
        </p:nvPicPr>
        <p:blipFill>
          <a:blip r:embed="rId2"/>
          <a:srcRect l="11333" t="14842" r="24802" b="17185"/>
          <a:stretch/>
        </p:blipFill>
        <p:spPr>
          <a:xfrm>
            <a:off x="2857680" y="3214800"/>
            <a:ext cx="2236680" cy="17859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3" descr="G:\Projects\Longhorns, Leucinodes and Tuta\Leucinodes\Leucinodes images\IMG_20161004_124742592.jpg"/>
          <p:cNvPicPr/>
          <p:nvPr/>
        </p:nvPicPr>
        <p:blipFill>
          <a:blip r:embed="rId3"/>
          <a:srcRect l="12683" t="0" r="21881" b="0"/>
          <a:stretch/>
        </p:blipFill>
        <p:spPr>
          <a:xfrm>
            <a:off x="1000080" y="4357800"/>
            <a:ext cx="2286000" cy="1965240"/>
          </a:xfrm>
          <a:prstGeom prst="rect">
            <a:avLst/>
          </a:prstGeom>
          <a:ln w="0">
            <a:noFill/>
          </a:ln>
        </p:spPr>
      </p:pic>
      <p:sp>
        <p:nvSpPr>
          <p:cNvPr id="46" name="TextBox 9"/>
          <p:cNvSpPr/>
          <p:nvPr/>
        </p:nvSpPr>
        <p:spPr>
          <a:xfrm rot="2352000">
            <a:off x="3771360" y="1418040"/>
            <a:ext cx="1324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Genome min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 rot="20082600">
            <a:off x="429840" y="2053080"/>
            <a:ext cx="13240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Eggplant shoot &amp; fruit bor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 rot="20614800">
            <a:off x="2980440" y="7616880"/>
            <a:ext cx="1924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se of reduced risk pesticid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2"/>
          <p:cNvSpPr/>
          <p:nvPr/>
        </p:nvSpPr>
        <p:spPr>
          <a:xfrm rot="3663600">
            <a:off x="4892760" y="2917800"/>
            <a:ext cx="1324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Metabolic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 rot="4900800">
            <a:off x="5369040" y="4702680"/>
            <a:ext cx="1847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Gene expression profil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4"/>
          <p:cNvSpPr/>
          <p:nvPr/>
        </p:nvSpPr>
        <p:spPr>
          <a:xfrm rot="8513400">
            <a:off x="5203080" y="6557400"/>
            <a:ext cx="1323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Resistance detec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5"/>
          <p:cNvSpPr/>
          <p:nvPr/>
        </p:nvSpPr>
        <p:spPr>
          <a:xfrm rot="20082600">
            <a:off x="1931400" y="1395360"/>
            <a:ext cx="1323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Insecticide resista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Kariyanna B Desai</dc:creator>
  <dc:description/>
  <dc:language>en-US</dc:language>
  <cp:lastModifiedBy>Mohan</cp:lastModifiedBy>
  <dcterms:modified xsi:type="dcterms:W3CDTF">2019-04-03T07:17:09Z</dcterms:modified>
  <cp:revision>9</cp:revision>
  <dc:subject/>
  <dc:title>PowerPoint Presentation</dc:title>
</cp:coreProperties>
</file>